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3B5B74-853E-4F30-A386-AD06A5665C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C15CADC-D7D6-421E-8954-2AD94C452E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1B615A-470A-47ED-8AD0-A0CC000E5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AFDE8B-A0E0-4E75-A017-B9881C74E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F0C125-9746-4EB2-AFAB-29EEB5DC9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927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C25043-13AB-436B-8A4F-6951C52047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49C4478-7F55-4659-9851-CD73BA1D6E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23BAAD-B139-4486-BA39-CB1944518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17A0A9-AFFC-4C41-8EA5-FE1371853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C20B74-DF2E-4912-9455-D1EB712A6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4677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A8FD01F-9B73-4A7E-84E3-16301478F4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60500BF-92DB-4FCA-B11E-50599DFFF0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BD271F-17A7-403B-AA01-60EFCCC6F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05ABA7-2E3C-475F-BAD2-A4BB31E87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C04E70-FA2D-4941-87A2-D18970953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1732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20A6F7-1089-473A-94B0-68262981B6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21B639-BA88-46AB-979D-361A24DED7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63A4ED-1E68-4ABB-8999-A8020789B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D2A2E1-BC7A-4108-95EE-833B530CF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4C4DE0-89C1-46D6-8497-19EADA7D4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4611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F46BFE-8031-4C2E-8512-E0370965C5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C6DA17-9209-4EF1-98C1-4AD6A0BB9E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9C4C34-7C80-4CBE-B8A8-CE03E02CBC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51C0DB-085A-4811-9AA2-BCCE43AEC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1F5EE5-9FF7-458E-8ACB-F08E2CF6A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9423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17955C-09C8-43BE-A1CA-600F85502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79038C-A2FE-400B-A3D7-01E0EC9AB3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D6F5A11-F296-4E87-91CB-709EBE684D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70AB5AF-495B-4DCC-A46E-5E876DA6C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4522D1-6705-4C35-831D-9E57C2930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6ED5EA-52F9-4754-B6B2-29C18B661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2167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947C73-6D92-4992-9D2D-EDEEE0EA2E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E178DA-18B9-484C-A811-4B4A51230A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15293A4-4CD1-4B7E-8AAD-54736826A7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A71D9C9-5B92-429B-B7BF-93DF6DA730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4564943-8AE1-4027-BEE1-122499CB0C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FD98A0D-6356-44F8-9D54-520893208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8EF76AC-C867-4471-B975-EB4B88A5C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EA22622-7E5D-475C-9D7A-53296B135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4026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FA19D1-6E93-4983-B62E-A74AB0AE7D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9FB4C06-58F3-425A-8FDB-C9C1A2ACE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37CC5C9-660F-44C6-A044-4A67EE90A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87B1CE0-1A90-4D07-9B2B-D4BA04E42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7354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6A4527D-84DA-4630-B608-1626CAA72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274B2B3-76AC-4AFF-9A2C-AE93AE1E7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1D319D6-8452-4C64-80ED-1B71C03A8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979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BEA5E4-AD6D-4218-B77C-6D507FB4FA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3ADA43F-6455-46B4-894F-5491AC0EA4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EF47ADF-2006-4A63-81C8-8480FEB34D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6160BED-9E26-496E-8A9F-D7EF3A89B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BDE062-584D-41F6-AD6C-0506E2A21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C3B019-0B14-45FF-87C1-1AF2A81D6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033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4FB84C-B678-481C-9E9E-92AAF7F657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A288B70-4F0D-4671-BC55-967DFC1FA9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0663FBF-CA33-4DF1-B992-D516511F91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F4193A-0C90-48CB-85BB-4975CF6AA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4737EF1-521E-45DC-ADA9-2E7B72C16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BA44675-D0D7-4D89-8146-15B14D33B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8495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3A6EC73-302D-4187-A649-AB52B077F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DD0674-B838-4351-8C63-9501DFAC8F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E91614-B48D-4156-9CDC-AFA128751E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CD5E5B-29C8-4C68-94ED-D0411C064699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6F5B65-796E-4BFA-8EFB-E506121513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2BDA0D7-11E5-4BA2-862D-203D34796B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21005-49BE-49D6-9F8A-302ED68879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117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F498125-6A04-48C7-BC3A-626AEC2629E8}"/>
              </a:ext>
            </a:extLst>
          </p:cNvPr>
          <p:cNvSpPr txBox="1"/>
          <p:nvPr/>
        </p:nvSpPr>
        <p:spPr>
          <a:xfrm>
            <a:off x="339569" y="125104"/>
            <a:ext cx="5837526" cy="4053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3. Histological assessment of liver in NASH mice after intervention stained with HE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B50829A-6103-4927-B029-85494CE2B6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907" y="530471"/>
            <a:ext cx="2485000" cy="584136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25040D5D-A527-4142-A45C-2995ABAAF8EF}"/>
              </a:ext>
            </a:extLst>
          </p:cNvPr>
          <p:cNvSpPr txBox="1"/>
          <p:nvPr/>
        </p:nvSpPr>
        <p:spPr>
          <a:xfrm>
            <a:off x="71021" y="6396335"/>
            <a:ext cx="1173036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1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tervention groups: EHFD, exercise plus high fat diet; ELFD, exercise plus low fat diet; HE, </a:t>
            </a:r>
            <a:r>
              <a:rPr lang="en-US" altLang="zh-C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haematoxylin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and eosin; HFD, high fat diet; LFD, low fat diet; MCSM, methionine choline sufficient diet (4 weeks). None intervention groups: MCD, methionine choline deficiency diet (8 weeks); MCSC, methionine choline sufficient diet (8 weeks). Scale bars = 100 </a:t>
            </a:r>
            <a:r>
              <a:rPr lang="el-GR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μ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.</a:t>
            </a:r>
            <a:endParaRPr lang="zh-CN" altLang="en-US" sz="1200" dirty="0"/>
          </a:p>
          <a:p>
            <a:pPr algn="just"/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347429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95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 Na</dc:creator>
  <cp:lastModifiedBy>Wu Na</cp:lastModifiedBy>
  <cp:revision>2</cp:revision>
  <dcterms:created xsi:type="dcterms:W3CDTF">2021-08-16T11:09:11Z</dcterms:created>
  <dcterms:modified xsi:type="dcterms:W3CDTF">2021-08-16T11:30:44Z</dcterms:modified>
</cp:coreProperties>
</file>